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4">
          <p15:clr>
            <a:srgbClr val="A4A3A4"/>
          </p15:clr>
        </p15:guide>
        <p15:guide id="2" pos="2880">
          <p15:clr>
            <a:srgbClr val="A4A3A4"/>
          </p15:clr>
        </p15:guide>
        <p15:guide id="3" orient="horz" pos="3796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Corinne Chauvat" initials="C" lastIdx="0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D00E1"/>
    <a:srgbClr val="4DFF0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266"/>
    <p:restoredTop sz="94632"/>
  </p:normalViewPr>
  <p:slideViewPr>
    <p:cSldViewPr snapToGrid="0" snapToObjects="1" showGuides="1">
      <p:cViewPr varScale="1">
        <p:scale>
          <a:sx n="154" d="100"/>
          <a:sy n="154" d="100"/>
        </p:scale>
        <p:origin x="2912" y="200"/>
      </p:cViewPr>
      <p:guideLst>
        <p:guide orient="horz" pos="2164"/>
        <p:guide pos="2880"/>
        <p:guide orient="horz" pos="379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0AE8820-6ACE-F948-8FD9-3287D7E6CDCC}" type="datetimeFigureOut">
              <a:rPr lang="en-GB" smtClean="0"/>
              <a:pPr/>
              <a:t>14/11/2023</a:t>
            </a:fld>
            <a:endParaRPr lang="en-GB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47C44A-2E0D-BC40-BDA8-E2150063FFC1}" type="slidenum">
              <a:rPr lang="en-GB" smtClean="0"/>
              <a:pPr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23192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6ABE1-17DC-614C-85A6-E04C023FF368}" type="datetimeFigureOut">
              <a:rPr lang="fr-FR" smtClean="0"/>
              <a:pPr/>
              <a:t>14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194C7-6749-1447-A414-F86F8396F115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6ABE1-17DC-614C-85A6-E04C023FF368}" type="datetimeFigureOut">
              <a:rPr lang="fr-FR" smtClean="0"/>
              <a:pPr/>
              <a:t>14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194C7-6749-1447-A414-F86F8396F115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6ABE1-17DC-614C-85A6-E04C023FF368}" type="datetimeFigureOut">
              <a:rPr lang="fr-FR" smtClean="0"/>
              <a:pPr/>
              <a:t>14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194C7-6749-1447-A414-F86F8396F115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6ABE1-17DC-614C-85A6-E04C023FF368}" type="datetimeFigureOut">
              <a:rPr lang="fr-FR" smtClean="0"/>
              <a:pPr/>
              <a:t>14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194C7-6749-1447-A414-F86F8396F115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6ABE1-17DC-614C-85A6-E04C023FF368}" type="datetimeFigureOut">
              <a:rPr lang="fr-FR" smtClean="0"/>
              <a:pPr/>
              <a:t>14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194C7-6749-1447-A414-F86F8396F115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6ABE1-17DC-614C-85A6-E04C023FF368}" type="datetimeFigureOut">
              <a:rPr lang="fr-FR" smtClean="0"/>
              <a:pPr/>
              <a:t>14/11/202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194C7-6749-1447-A414-F86F8396F115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6ABE1-17DC-614C-85A6-E04C023FF368}" type="datetimeFigureOut">
              <a:rPr lang="fr-FR" smtClean="0"/>
              <a:pPr/>
              <a:t>14/11/2023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194C7-6749-1447-A414-F86F8396F115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6ABE1-17DC-614C-85A6-E04C023FF368}" type="datetimeFigureOut">
              <a:rPr lang="fr-FR" smtClean="0"/>
              <a:pPr/>
              <a:t>14/11/2023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194C7-6749-1447-A414-F86F8396F115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6ABE1-17DC-614C-85A6-E04C023FF368}" type="datetimeFigureOut">
              <a:rPr lang="fr-FR" smtClean="0"/>
              <a:pPr/>
              <a:t>14/11/2023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194C7-6749-1447-A414-F86F8396F115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6ABE1-17DC-614C-85A6-E04C023FF368}" type="datetimeFigureOut">
              <a:rPr lang="fr-FR" smtClean="0"/>
              <a:pPr/>
              <a:t>14/11/202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194C7-6749-1447-A414-F86F8396F115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6ABE1-17DC-614C-85A6-E04C023FF368}" type="datetimeFigureOut">
              <a:rPr lang="fr-FR" smtClean="0"/>
              <a:pPr/>
              <a:t>14/11/202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194C7-6749-1447-A414-F86F8396F115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56ABE1-17DC-614C-85A6-E04C023FF368}" type="datetimeFigureOut">
              <a:rPr lang="fr-FR" smtClean="0"/>
              <a:pPr/>
              <a:t>14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5194C7-6749-1447-A414-F86F8396F115}" type="slidenum">
              <a:rPr lang="en-US" smtClean="0"/>
              <a:pPr/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ZoneTexte 45">
            <a:extLst>
              <a:ext uri="{FF2B5EF4-FFF2-40B4-BE49-F238E27FC236}">
                <a16:creationId xmlns:a16="http://schemas.microsoft.com/office/drawing/2014/main" id="{7039E761-0356-D9B8-5426-6791FDD1B980}"/>
              </a:ext>
            </a:extLst>
          </p:cNvPr>
          <p:cNvSpPr txBox="1"/>
          <p:nvPr/>
        </p:nvSpPr>
        <p:spPr>
          <a:xfrm>
            <a:off x="69186" y="5267930"/>
            <a:ext cx="8936417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Physical map of the </a:t>
            </a:r>
            <a:r>
              <a:rPr lang="en-GB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derived plasmids expressing the studied </a:t>
            </a:r>
            <a:r>
              <a:rPr lang="en-GB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bc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perons </a:t>
            </a:r>
          </a:p>
          <a:p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ematic representation of the genomic regions encompassing the </a:t>
            </a:r>
            <a:r>
              <a:rPr lang="en-GB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bc</a:t>
            </a:r>
            <a:r>
              <a:rPr lang="en-GB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peron of S.6803, S.7002, S.7942 or C7425. </a:t>
            </a:r>
            <a:r>
              <a:rPr lang="en-GB" sz="1100" noProof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ll genes are represented by colored arrows pointing into the direction of their transcription. 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ysical map of the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derived plasmids expressing the studied </a:t>
            </a:r>
            <a:r>
              <a:rPr lang="en-GB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bc</a:t>
            </a:r>
            <a:r>
              <a:rPr lang="en-GB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perons from the strong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GB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moter (small red triangle). The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m</a:t>
            </a:r>
            <a:r>
              <a:rPr lang="en-GB" sz="11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</a:t>
            </a:r>
            <a:r>
              <a:rPr lang="en-GB" sz="11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tibiotic-resistant marker flanked by transcription terminator (TT) are shown in red arrows and orange rectangles, respectively. The dark-green arrow indicated as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m</a:t>
            </a:r>
            <a:r>
              <a:rPr lang="en-GB" sz="11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ands for the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m</a:t>
            </a:r>
            <a:r>
              <a:rPr lang="en-GB" sz="11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which was inactivated during the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onings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the </a:t>
            </a:r>
            <a:r>
              <a:rPr lang="en-GB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bc</a:t>
            </a:r>
            <a:r>
              <a:rPr lang="en-GB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perons. The other parts designated as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pABC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iV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iT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and for the RSF1010 machinery for conjugative transfer to, and replication in, cyanobacteria.</a:t>
            </a:r>
          </a:p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 </a:t>
            </a:r>
            <a:r>
              <a:rPr lang="fr-F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ypical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V-light images of the agarose gels </a:t>
            </a:r>
            <a:r>
              <a:rPr lang="fr-F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owing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relevant PCR </a:t>
            </a:r>
            <a:r>
              <a:rPr lang="fr-F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ducts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fr-F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lored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ctangles) of clones (C1-C3) </a:t>
            </a:r>
            <a:r>
              <a:rPr lang="fr-F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rboring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fr-F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udied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asmids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Size marker (</a:t>
            </a:r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= 1 kb Plus DNA Ladder (</a:t>
            </a:r>
            <a:r>
              <a:rPr lang="fr-F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vitrogen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en-GB" sz="11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5" name="Image 14">
            <a:extLst>
              <a:ext uri="{FF2B5EF4-FFF2-40B4-BE49-F238E27FC236}">
                <a16:creationId xmlns:a16="http://schemas.microsoft.com/office/drawing/2014/main" id="{115B55A6-4034-02A7-375A-4C74EA05157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3004" y="59665"/>
            <a:ext cx="8699288" cy="5179051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421</TotalTime>
  <Words>193</Words>
  <Application>Microsoft Macintosh PowerPoint</Application>
  <PresentationFormat>Affichage à l'écran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Corinne Chauvat</dc:creator>
  <cp:lastModifiedBy>Franck Chauvat</cp:lastModifiedBy>
  <cp:revision>40</cp:revision>
  <dcterms:created xsi:type="dcterms:W3CDTF">2023-10-17T09:17:10Z</dcterms:created>
  <dcterms:modified xsi:type="dcterms:W3CDTF">2023-11-14T10:03:55Z</dcterms:modified>
</cp:coreProperties>
</file>